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56"/>
  </p:normalViewPr>
  <p:slideViewPr>
    <p:cSldViewPr snapToGrid="0" snapToObjects="1">
      <p:cViewPr varScale="1">
        <p:scale>
          <a:sx n="62" d="100"/>
          <a:sy n="62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4E7FA5-6477-EC4D-8C59-E9C8BD8DE0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2E9169-669F-0C49-84AE-0C3BDC45A8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7FCBBD-541A-2749-9BFA-B59B4577B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7E2B4-F294-E845-920B-7CFA7BF38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D6C454-BE71-B749-B571-F97B2EDEE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348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8E1EE8-2601-5D4B-9189-BD251AC916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06C1FD-6CF3-1948-86F7-9718A5128E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A54089-58EA-3145-97D5-E6B5D8B36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C62B24-AA13-F245-9E5D-31137B66E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74C04A-9344-6045-92D7-20631B8B6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272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080C11-56B4-A742-897A-5A80F6A10E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666073-98D9-AA46-9E02-FBD1A1F088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2CC53F-5F19-544F-AE78-144489EF1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F76D6-840D-9642-B0C1-31D28AFFB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319F6A-548A-B241-A27C-D0FD51E76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488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A1D47F-28A9-8A4E-AA61-1E2453F8DB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9FD151-180A-F245-88A4-E3A28F1C7B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7668B-E0A5-BF44-A5F2-E04417E4F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4C166E-95E8-C944-825D-F47A81E3C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BBE3A-9D56-0541-910E-D4D7CE4D5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395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2BA897-E98B-AA4E-98D5-8F0DFC750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5EA1E5-68D4-D442-BB8D-DF6AFA05B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802B0B-F88E-4E4E-8208-239EB41A3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7743F8-0D31-ED40-AF9E-6DAFB4D9F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D33717-DB3A-2049-AEB5-8DFCCB78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318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3639B8-D67F-9C4E-BBB7-B453664A04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E69DB2-3109-F44A-9F6F-159CFEB40D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8E1352-EB84-0C45-BD1D-4102DBFED7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814A8A-1524-BC49-A5C2-6EB94CA58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591647-A1C4-174B-83A3-1D8C513B8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5D466C-1FC8-FF4F-9BCD-D9BBA13F2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348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0F70BA-D33D-CD40-855D-EAD5786C79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0EDA1A-602C-CF47-ADF7-26E06D7213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000529-074C-3A41-AD18-5AFD7CB1C9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6B10E6-A4A3-8A43-AB1E-AC79F508FD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1423AD-14BE-B84A-A2A7-A0263585F5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26430E9-250B-D440-ADC3-157B2C3E1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0F6BCF-F864-D344-A7E9-71B6EA01C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2C109B-CAA1-BD46-B531-2496BE8CD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723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1BDD8-4822-014B-9ED0-DD1993DAC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98FFC0-AFE2-D44A-B5CA-FC386A8B4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8A1ABF-5A88-C645-ADED-297EE4052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419FD2-99A5-0E48-AE62-36E4D6B7E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521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34E236-8925-814E-A3A3-5E198C3DB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D48367C-9F95-6046-93AC-F84687C2A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45B566-FCEF-3341-BC98-515033128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115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FCEC88-936C-7D43-A9A2-0A8FCB5AAC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1FDC07-F6F6-5842-A8A6-1233A75693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444119-ED72-D742-89EC-5A5BE7285F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E6C62F-0867-894A-AA0D-45AC66473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EBCA57-4BFA-F643-808F-7527D4B7A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7C9986-A54D-2246-927E-F7C197B13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789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1EAF8-A4A8-624B-800A-A3FF64D89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B13740-14E1-7C45-83CF-33CDAD1334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34181F-53A1-7347-8C81-5E5311F3EB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556158-844A-EC4A-861C-F9522562E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375C7D-77E2-9F4B-B764-B19B4113F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6B37AC-5CCA-0F4A-8128-793829A69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39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6341DE-9AEA-6D4F-8568-8795B7F2D4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C844EC-DB55-7844-B3AC-7DF6B81E6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311B66-2F91-EB4B-8F89-48E9A1FA16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F62A3-CDA7-2548-9F90-DFF62F233873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62E368-2747-4D4E-89AF-AC56DC5C97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1A01D3-BFD9-4446-82F5-21AD518544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7C0DD-CF8E-7C48-8827-98DA20DA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411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hyperlink" Target="https://journals.plos.org/plosbiology/article?id=10.1371/journal.pbio.1000296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ctangle 3">
            <a:extLst>
              <a:ext uri="{FF2B5EF4-FFF2-40B4-BE49-F238E27FC236}">
                <a16:creationId xmlns:a16="http://schemas.microsoft.com/office/drawing/2014/main" id="{70BDEC3C-866D-F24B-9E15-C681751A8239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>
          <a:xfrm>
            <a:off x="1972235" y="246529"/>
            <a:ext cx="8258735" cy="483466"/>
          </a:xfrm>
          <a:noFill/>
          <a:ln/>
        </p:spPr>
        <p:txBody>
          <a:bodyPr>
            <a:spAutoFit/>
          </a:bodyPr>
          <a:lstStyle/>
          <a:p>
            <a:pPr marL="0" indent="0" algn="ctr">
              <a:spcBef>
                <a:spcPct val="0"/>
              </a:spcBef>
              <a:buNone/>
            </a:pPr>
            <a:r>
              <a:rPr lang="en-US" altLang="en-US" sz="1412" b="1">
                <a:solidFill>
                  <a:schemeClr val="tx2"/>
                </a:solidFill>
              </a:rPr>
              <a:t>Figure 7. SATB1 and β-catenin regulate expression of GATA3 and TH2 cytokines in a Wnt-dependent manner in differentiating TH2 cells.</a:t>
            </a:r>
          </a:p>
        </p:txBody>
      </p:sp>
      <p:sp>
        <p:nvSpPr>
          <p:cNvPr id="4100" name="Text Box 4">
            <a:extLst>
              <a:ext uri="{FF2B5EF4-FFF2-40B4-BE49-F238E27FC236}">
                <a16:creationId xmlns:a16="http://schemas.microsoft.com/office/drawing/2014/main" id="{7CBEE80D-192F-274A-8920-8B49474061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0676" y="5748618"/>
            <a:ext cx="8101853" cy="581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eaLnBrk="1" hangingPunct="1"/>
            <a:r>
              <a:rPr lang="en-US" altLang="en-US" sz="1059"/>
              <a:t>Notani D, Gottimukkala KP, Jayani RS, Limaye AS, Damle MV, et al. (2010) Global Regulator SATB1 Recruits β-Catenin and Regulates TH2 Differentiation in Wnt-Dependent Manner. PLOS Biology 8(1): e1000296. https://doi.org/10.1371/journal.pbio.1000296</a:t>
            </a:r>
          </a:p>
          <a:p>
            <a:pPr eaLnBrk="1" hangingPunct="1"/>
            <a:r>
              <a:rPr lang="en-US" altLang="en-US" sz="1059">
                <a:hlinkClick r:id="rId2"/>
              </a:rPr>
              <a:t>https://journals.plos.org/plosbiology/article?id=10.1371/journal.pbio.1000296</a:t>
            </a:r>
            <a:endParaRPr lang="en-US" altLang="en-US" sz="1059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318B1CC-DD1B-4645-88B6-B7C24C2119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013" r="38809"/>
          <a:stretch/>
        </p:blipFill>
        <p:spPr>
          <a:xfrm>
            <a:off x="4929831" y="729995"/>
            <a:ext cx="2343541" cy="4863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4488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98FA290-062E-D342-BD80-8334DE9F93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4330" y="4045565"/>
            <a:ext cx="3289300" cy="1701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2EECAAA-836D-1249-8B02-E97A16E229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8801" y="3870891"/>
            <a:ext cx="4147952" cy="248566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D22C02C-C27D-694C-BD5C-78C20CC7AC6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7013" r="49983" b="65604"/>
          <a:stretch/>
        </p:blipFill>
        <p:spPr>
          <a:xfrm>
            <a:off x="3511945" y="0"/>
            <a:ext cx="2420563" cy="341911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D01ADEB-F7FF-1F4C-8989-407335D1F8D0}"/>
              </a:ext>
            </a:extLst>
          </p:cNvPr>
          <p:cNvSpPr/>
          <p:nvPr/>
        </p:nvSpPr>
        <p:spPr>
          <a:xfrm>
            <a:off x="2136928" y="4827089"/>
            <a:ext cx="1564918" cy="503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1DB9719-A4BA-9B4F-90A5-12AC7BBB0390}"/>
              </a:ext>
            </a:extLst>
          </p:cNvPr>
          <p:cNvSpPr/>
          <p:nvPr/>
        </p:nvSpPr>
        <p:spPr>
          <a:xfrm>
            <a:off x="4395019" y="4982671"/>
            <a:ext cx="1537489" cy="4361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8460B8B8-15F1-1148-8D4C-1A2E5032E36C}"/>
              </a:ext>
            </a:extLst>
          </p:cNvPr>
          <p:cNvCxnSpPr/>
          <p:nvPr/>
        </p:nvCxnSpPr>
        <p:spPr>
          <a:xfrm flipH="1">
            <a:off x="2713703" y="2802194"/>
            <a:ext cx="1681316" cy="1828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987CCBC-9242-7644-98DA-1DE91B7CF7D8}"/>
              </a:ext>
            </a:extLst>
          </p:cNvPr>
          <p:cNvCxnSpPr/>
          <p:nvPr/>
        </p:nvCxnSpPr>
        <p:spPr>
          <a:xfrm>
            <a:off x="5117690" y="3274142"/>
            <a:ext cx="117987" cy="15529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07737AD3-AB27-B149-8C7D-E4DFDCC18DF4}"/>
              </a:ext>
            </a:extLst>
          </p:cNvPr>
          <p:cNvSpPr txBox="1"/>
          <p:nvPr/>
        </p:nvSpPr>
        <p:spPr>
          <a:xfrm>
            <a:off x="1150374" y="324465"/>
            <a:ext cx="13620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7A</a:t>
            </a:r>
          </a:p>
        </p:txBody>
      </p:sp>
    </p:spTree>
    <p:extLst>
      <p:ext uri="{BB962C8B-B14F-4D97-AF65-F5344CB8AC3E}">
        <p14:creationId xmlns:p14="http://schemas.microsoft.com/office/powerpoint/2010/main" val="9845373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B87CFA-ACE6-2D4E-84A2-909EBFAC725E}"/>
              </a:ext>
            </a:extLst>
          </p:cNvPr>
          <p:cNvSpPr txBox="1"/>
          <p:nvPr/>
        </p:nvSpPr>
        <p:spPr>
          <a:xfrm>
            <a:off x="1064757" y="217777"/>
            <a:ext cx="1419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 7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710348E-773F-264D-9212-734B6C927B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7222" y="4277033"/>
            <a:ext cx="6272519" cy="177466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7303B01-EDE4-394E-A757-28285C88E2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083" r="38809" b="64366"/>
          <a:stretch/>
        </p:blipFill>
        <p:spPr>
          <a:xfrm>
            <a:off x="4645742" y="0"/>
            <a:ext cx="2612881" cy="3858484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9F995FF5-4E4B-2444-9DDB-3CD4EEDA6278}"/>
              </a:ext>
            </a:extLst>
          </p:cNvPr>
          <p:cNvCxnSpPr>
            <a:cxnSpLocks/>
          </p:cNvCxnSpPr>
          <p:nvPr/>
        </p:nvCxnSpPr>
        <p:spPr>
          <a:xfrm flipH="1">
            <a:off x="3687097" y="3038168"/>
            <a:ext cx="1578078" cy="20795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9023513-BEA1-4A46-9F4B-C8558BD1C258}"/>
              </a:ext>
            </a:extLst>
          </p:cNvPr>
          <p:cNvCxnSpPr/>
          <p:nvPr/>
        </p:nvCxnSpPr>
        <p:spPr>
          <a:xfrm flipH="1">
            <a:off x="5265174" y="3038168"/>
            <a:ext cx="973394" cy="20795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E4D0A7B-700E-FB4A-8454-A7EC42E3F530}"/>
              </a:ext>
            </a:extLst>
          </p:cNvPr>
          <p:cNvCxnSpPr/>
          <p:nvPr/>
        </p:nvCxnSpPr>
        <p:spPr>
          <a:xfrm>
            <a:off x="5973097" y="3215148"/>
            <a:ext cx="855406" cy="190254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23DC68F3-5492-0343-A584-751FA11CA699}"/>
              </a:ext>
            </a:extLst>
          </p:cNvPr>
          <p:cNvCxnSpPr/>
          <p:nvPr/>
        </p:nvCxnSpPr>
        <p:spPr>
          <a:xfrm>
            <a:off x="6828503" y="3215148"/>
            <a:ext cx="1474839" cy="175505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CC577437-79BC-FC4A-8066-6DBB9E76DD80}"/>
              </a:ext>
            </a:extLst>
          </p:cNvPr>
          <p:cNvSpPr/>
          <p:nvPr/>
        </p:nvSpPr>
        <p:spPr>
          <a:xfrm>
            <a:off x="2907223" y="5235677"/>
            <a:ext cx="1281320" cy="412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342C7CB-335B-CC44-BA3D-E1C2E5DBAED3}"/>
              </a:ext>
            </a:extLst>
          </p:cNvPr>
          <p:cNvSpPr/>
          <p:nvPr/>
        </p:nvSpPr>
        <p:spPr>
          <a:xfrm>
            <a:off x="4572002" y="5285517"/>
            <a:ext cx="1209366" cy="412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0F9EDBE-2EDF-654B-AF7D-4B42FDCDB738}"/>
              </a:ext>
            </a:extLst>
          </p:cNvPr>
          <p:cNvSpPr/>
          <p:nvPr/>
        </p:nvSpPr>
        <p:spPr>
          <a:xfrm>
            <a:off x="6209071" y="5171738"/>
            <a:ext cx="1209366" cy="412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66F5ADD-5C83-0F47-BC55-F51CC2A29A75}"/>
              </a:ext>
            </a:extLst>
          </p:cNvPr>
          <p:cNvSpPr/>
          <p:nvPr/>
        </p:nvSpPr>
        <p:spPr>
          <a:xfrm>
            <a:off x="7859103" y="5156990"/>
            <a:ext cx="1209366" cy="412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21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ple Notani</dc:creator>
  <cp:lastModifiedBy>Alice Coles-Aldridge</cp:lastModifiedBy>
  <cp:revision>8</cp:revision>
  <dcterms:created xsi:type="dcterms:W3CDTF">2021-12-06T16:49:14Z</dcterms:created>
  <dcterms:modified xsi:type="dcterms:W3CDTF">2022-06-09T14:06:35Z</dcterms:modified>
</cp:coreProperties>
</file>